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5486400" cy="9051925"/>
  <p:notesSz cx="6858000" cy="9144000"/>
  <p:defaultTextStyle>
    <a:defPPr>
      <a:defRPr lang="en-US"/>
    </a:defPPr>
    <a:lvl1pPr marL="0" algn="l" defTabSz="830732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1pPr>
    <a:lvl2pPr marL="415366" algn="l" defTabSz="830732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2pPr>
    <a:lvl3pPr marL="830732" algn="l" defTabSz="830732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3pPr>
    <a:lvl4pPr marL="1246099" algn="l" defTabSz="830732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4pPr>
    <a:lvl5pPr marL="1661465" algn="l" defTabSz="830732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5pPr>
    <a:lvl6pPr marL="2076831" algn="l" defTabSz="830732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6pPr>
    <a:lvl7pPr marL="2492197" algn="l" defTabSz="830732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7pPr>
    <a:lvl8pPr marL="2907563" algn="l" defTabSz="830732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8pPr>
    <a:lvl9pPr marL="3322930" algn="l" defTabSz="830732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38" d="100"/>
          <a:sy n="38" d="100"/>
        </p:scale>
        <p:origin x="-1690" y="-67"/>
      </p:cViewPr>
      <p:guideLst>
        <p:guide orient="horz" pos="2851"/>
        <p:guide pos="172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11480" y="2811965"/>
            <a:ext cx="4663440" cy="194029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22960" y="5129424"/>
            <a:ext cx="3840480" cy="231327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153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307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4609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614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0768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4921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9075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3229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A328E-3710-46B4-9798-B82AA598517D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C2A6D-3FEC-463A-8F3D-9DCDE3C1F37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A328E-3710-46B4-9798-B82AA598517D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C2A6D-3FEC-463A-8F3D-9DCDE3C1F37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977640" y="362498"/>
            <a:ext cx="1234440" cy="7723471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74320" y="362498"/>
            <a:ext cx="3611880" cy="7723471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A328E-3710-46B4-9798-B82AA598517D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C2A6D-3FEC-463A-8F3D-9DCDE3C1F37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A328E-3710-46B4-9798-B82AA598517D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C2A6D-3FEC-463A-8F3D-9DCDE3C1F37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3388" y="5816700"/>
            <a:ext cx="4663440" cy="1797813"/>
          </a:xfrm>
        </p:spPr>
        <p:txBody>
          <a:bodyPr anchor="t"/>
          <a:lstStyle>
            <a:lvl1pPr algn="l">
              <a:defRPr sz="36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3388" y="3836593"/>
            <a:ext cx="4663440" cy="1980108"/>
          </a:xfrm>
        </p:spPr>
        <p:txBody>
          <a:bodyPr anchor="b"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4153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83073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3pPr>
            <a:lvl4pPr marL="1246099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4pPr>
            <a:lvl5pPr marL="1661465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5pPr>
            <a:lvl6pPr marL="2076831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6pPr>
            <a:lvl7pPr marL="2492197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7pPr>
            <a:lvl8pPr marL="2907563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8pPr>
            <a:lvl9pPr marL="332293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A328E-3710-46B4-9798-B82AA598517D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C2A6D-3FEC-463A-8F3D-9DCDE3C1F37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74320" y="2112117"/>
            <a:ext cx="2423160" cy="5973852"/>
          </a:xfrm>
        </p:spPr>
        <p:txBody>
          <a:bodyPr/>
          <a:lstStyle>
            <a:lvl1pPr>
              <a:defRPr sz="2500"/>
            </a:lvl1pPr>
            <a:lvl2pPr>
              <a:defRPr sz="22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788920" y="2112117"/>
            <a:ext cx="2423160" cy="5973852"/>
          </a:xfrm>
        </p:spPr>
        <p:txBody>
          <a:bodyPr/>
          <a:lstStyle>
            <a:lvl1pPr>
              <a:defRPr sz="2500"/>
            </a:lvl1pPr>
            <a:lvl2pPr>
              <a:defRPr sz="22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A328E-3710-46B4-9798-B82AA598517D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C2A6D-3FEC-463A-8F3D-9DCDE3C1F37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74320" y="2026206"/>
            <a:ext cx="2424113" cy="844427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15366" indent="0">
              <a:buNone/>
              <a:defRPr sz="1800" b="1"/>
            </a:lvl2pPr>
            <a:lvl3pPr marL="830732" indent="0">
              <a:buNone/>
              <a:defRPr sz="1600" b="1"/>
            </a:lvl3pPr>
            <a:lvl4pPr marL="1246099" indent="0">
              <a:buNone/>
              <a:defRPr sz="1500" b="1"/>
            </a:lvl4pPr>
            <a:lvl5pPr marL="1661465" indent="0">
              <a:buNone/>
              <a:defRPr sz="1500" b="1"/>
            </a:lvl5pPr>
            <a:lvl6pPr marL="2076831" indent="0">
              <a:buNone/>
              <a:defRPr sz="1500" b="1"/>
            </a:lvl6pPr>
            <a:lvl7pPr marL="2492197" indent="0">
              <a:buNone/>
              <a:defRPr sz="1500" b="1"/>
            </a:lvl7pPr>
            <a:lvl8pPr marL="2907563" indent="0">
              <a:buNone/>
              <a:defRPr sz="1500" b="1"/>
            </a:lvl8pPr>
            <a:lvl9pPr marL="3322930" indent="0">
              <a:buNone/>
              <a:defRPr sz="15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74320" y="2870633"/>
            <a:ext cx="2424113" cy="5215334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6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787015" y="2026206"/>
            <a:ext cx="2425065" cy="844427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15366" indent="0">
              <a:buNone/>
              <a:defRPr sz="1800" b="1"/>
            </a:lvl2pPr>
            <a:lvl3pPr marL="830732" indent="0">
              <a:buNone/>
              <a:defRPr sz="1600" b="1"/>
            </a:lvl3pPr>
            <a:lvl4pPr marL="1246099" indent="0">
              <a:buNone/>
              <a:defRPr sz="1500" b="1"/>
            </a:lvl4pPr>
            <a:lvl5pPr marL="1661465" indent="0">
              <a:buNone/>
              <a:defRPr sz="1500" b="1"/>
            </a:lvl5pPr>
            <a:lvl6pPr marL="2076831" indent="0">
              <a:buNone/>
              <a:defRPr sz="1500" b="1"/>
            </a:lvl6pPr>
            <a:lvl7pPr marL="2492197" indent="0">
              <a:buNone/>
              <a:defRPr sz="1500" b="1"/>
            </a:lvl7pPr>
            <a:lvl8pPr marL="2907563" indent="0">
              <a:buNone/>
              <a:defRPr sz="1500" b="1"/>
            </a:lvl8pPr>
            <a:lvl9pPr marL="3322930" indent="0">
              <a:buNone/>
              <a:defRPr sz="15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787015" y="2870633"/>
            <a:ext cx="2425065" cy="5215334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6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A328E-3710-46B4-9798-B82AA598517D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C2A6D-3FEC-463A-8F3D-9DCDE3C1F37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A328E-3710-46B4-9798-B82AA598517D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C2A6D-3FEC-463A-8F3D-9DCDE3C1F37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A328E-3710-46B4-9798-B82AA598517D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C2A6D-3FEC-463A-8F3D-9DCDE3C1F37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74320" y="360401"/>
            <a:ext cx="1804988" cy="1533798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145030" y="360401"/>
            <a:ext cx="3067050" cy="7725568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2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74320" y="1894200"/>
            <a:ext cx="1804988" cy="6191769"/>
          </a:xfrm>
        </p:spPr>
        <p:txBody>
          <a:bodyPr/>
          <a:lstStyle>
            <a:lvl1pPr marL="0" indent="0">
              <a:buNone/>
              <a:defRPr sz="1300"/>
            </a:lvl1pPr>
            <a:lvl2pPr marL="415366" indent="0">
              <a:buNone/>
              <a:defRPr sz="1100"/>
            </a:lvl2pPr>
            <a:lvl3pPr marL="830732" indent="0">
              <a:buNone/>
              <a:defRPr sz="900"/>
            </a:lvl3pPr>
            <a:lvl4pPr marL="1246099" indent="0">
              <a:buNone/>
              <a:defRPr sz="800"/>
            </a:lvl4pPr>
            <a:lvl5pPr marL="1661465" indent="0">
              <a:buNone/>
              <a:defRPr sz="800"/>
            </a:lvl5pPr>
            <a:lvl6pPr marL="2076831" indent="0">
              <a:buNone/>
              <a:defRPr sz="800"/>
            </a:lvl6pPr>
            <a:lvl7pPr marL="2492197" indent="0">
              <a:buNone/>
              <a:defRPr sz="800"/>
            </a:lvl7pPr>
            <a:lvl8pPr marL="2907563" indent="0">
              <a:buNone/>
              <a:defRPr sz="800"/>
            </a:lvl8pPr>
            <a:lvl9pPr marL="3322930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A328E-3710-46B4-9798-B82AA598517D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C2A6D-3FEC-463A-8F3D-9DCDE3C1F37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5373" y="6336348"/>
            <a:ext cx="3291840" cy="748042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075373" y="808806"/>
            <a:ext cx="3291840" cy="5431155"/>
          </a:xfrm>
        </p:spPr>
        <p:txBody>
          <a:bodyPr/>
          <a:lstStyle>
            <a:lvl1pPr marL="0" indent="0">
              <a:buNone/>
              <a:defRPr sz="2900"/>
            </a:lvl1pPr>
            <a:lvl2pPr marL="415366" indent="0">
              <a:buNone/>
              <a:defRPr sz="2500"/>
            </a:lvl2pPr>
            <a:lvl3pPr marL="830732" indent="0">
              <a:buNone/>
              <a:defRPr sz="2200"/>
            </a:lvl3pPr>
            <a:lvl4pPr marL="1246099" indent="0">
              <a:buNone/>
              <a:defRPr sz="1800"/>
            </a:lvl4pPr>
            <a:lvl5pPr marL="1661465" indent="0">
              <a:buNone/>
              <a:defRPr sz="1800"/>
            </a:lvl5pPr>
            <a:lvl6pPr marL="2076831" indent="0">
              <a:buNone/>
              <a:defRPr sz="1800"/>
            </a:lvl6pPr>
            <a:lvl7pPr marL="2492197" indent="0">
              <a:buNone/>
              <a:defRPr sz="1800"/>
            </a:lvl7pPr>
            <a:lvl8pPr marL="2907563" indent="0">
              <a:buNone/>
              <a:defRPr sz="1800"/>
            </a:lvl8pPr>
            <a:lvl9pPr marL="3322930" indent="0">
              <a:buNone/>
              <a:defRPr sz="18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75373" y="7084390"/>
            <a:ext cx="3291840" cy="1062343"/>
          </a:xfrm>
        </p:spPr>
        <p:txBody>
          <a:bodyPr/>
          <a:lstStyle>
            <a:lvl1pPr marL="0" indent="0">
              <a:buNone/>
              <a:defRPr sz="1300"/>
            </a:lvl1pPr>
            <a:lvl2pPr marL="415366" indent="0">
              <a:buNone/>
              <a:defRPr sz="1100"/>
            </a:lvl2pPr>
            <a:lvl3pPr marL="830732" indent="0">
              <a:buNone/>
              <a:defRPr sz="900"/>
            </a:lvl3pPr>
            <a:lvl4pPr marL="1246099" indent="0">
              <a:buNone/>
              <a:defRPr sz="800"/>
            </a:lvl4pPr>
            <a:lvl5pPr marL="1661465" indent="0">
              <a:buNone/>
              <a:defRPr sz="800"/>
            </a:lvl5pPr>
            <a:lvl6pPr marL="2076831" indent="0">
              <a:buNone/>
              <a:defRPr sz="800"/>
            </a:lvl6pPr>
            <a:lvl7pPr marL="2492197" indent="0">
              <a:buNone/>
              <a:defRPr sz="800"/>
            </a:lvl7pPr>
            <a:lvl8pPr marL="2907563" indent="0">
              <a:buNone/>
              <a:defRPr sz="800"/>
            </a:lvl8pPr>
            <a:lvl9pPr marL="3322930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A328E-3710-46B4-9798-B82AA598517D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C2A6D-3FEC-463A-8F3D-9DCDE3C1F37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74320" y="362497"/>
            <a:ext cx="4937760" cy="1508654"/>
          </a:xfrm>
          <a:prstGeom prst="rect">
            <a:avLst/>
          </a:prstGeom>
        </p:spPr>
        <p:txBody>
          <a:bodyPr vert="horz" lIns="83073" tIns="41537" rIns="83073" bIns="41537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74320" y="2112117"/>
            <a:ext cx="4937760" cy="5973852"/>
          </a:xfrm>
          <a:prstGeom prst="rect">
            <a:avLst/>
          </a:prstGeom>
        </p:spPr>
        <p:txBody>
          <a:bodyPr vert="horz" lIns="83073" tIns="41537" rIns="83073" bIns="41537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74320" y="8389795"/>
            <a:ext cx="1280160" cy="481931"/>
          </a:xfrm>
          <a:prstGeom prst="rect">
            <a:avLst/>
          </a:prstGeom>
        </p:spPr>
        <p:txBody>
          <a:bodyPr vert="horz" lIns="83073" tIns="41537" rIns="83073" bIns="41537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8A328E-3710-46B4-9798-B82AA598517D}" type="datetimeFigureOut">
              <a:rPr lang="en-US" smtClean="0"/>
              <a:t>7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874520" y="8389795"/>
            <a:ext cx="1737360" cy="481931"/>
          </a:xfrm>
          <a:prstGeom prst="rect">
            <a:avLst/>
          </a:prstGeom>
        </p:spPr>
        <p:txBody>
          <a:bodyPr vert="horz" lIns="83073" tIns="41537" rIns="83073" bIns="41537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931920" y="8389795"/>
            <a:ext cx="1280160" cy="481931"/>
          </a:xfrm>
          <a:prstGeom prst="rect">
            <a:avLst/>
          </a:prstGeom>
        </p:spPr>
        <p:txBody>
          <a:bodyPr vert="horz" lIns="83073" tIns="41537" rIns="83073" bIns="41537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7C2A6D-3FEC-463A-8F3D-9DCDE3C1F379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830732" rtl="0" eaLnBrk="1" latinLnBrk="0" hangingPunct="1">
        <a:spcBef>
          <a:spcPct val="0"/>
        </a:spcBef>
        <a:buNone/>
        <a:defRPr sz="4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11525" indent="-311525" algn="l" defTabSz="830732" rtl="0" eaLnBrk="1" latinLnBrk="0" hangingPunct="1">
        <a:spcBef>
          <a:spcPct val="20000"/>
        </a:spcBef>
        <a:buFont typeface="Arial" pitchFamily="34" charset="0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1pPr>
      <a:lvl2pPr marL="674970" indent="-259604" algn="l" defTabSz="830732" rtl="0" eaLnBrk="1" latinLnBrk="0" hangingPunct="1">
        <a:spcBef>
          <a:spcPct val="20000"/>
        </a:spcBef>
        <a:buFont typeface="Arial" pitchFamily="34" charset="0"/>
        <a:buChar char="–"/>
        <a:defRPr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038416" indent="-207683" algn="l" defTabSz="830732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453782" indent="-207683" algn="l" defTabSz="830732" rtl="0" eaLnBrk="1" latinLnBrk="0" hangingPunct="1">
        <a:spcBef>
          <a:spcPct val="20000"/>
        </a:spcBef>
        <a:buFont typeface="Arial" pitchFamily="34" charset="0"/>
        <a:buChar char="–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69148" indent="-207683" algn="l" defTabSz="830732" rtl="0" eaLnBrk="1" latinLnBrk="0" hangingPunct="1">
        <a:spcBef>
          <a:spcPct val="20000"/>
        </a:spcBef>
        <a:buFont typeface="Arial" pitchFamily="34" charset="0"/>
        <a:buChar char="»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4514" indent="-207683" algn="l" defTabSz="830732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699880" indent="-207683" algn="l" defTabSz="830732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15247" indent="-207683" algn="l" defTabSz="830732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530613" indent="-207683" algn="l" defTabSz="830732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30732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1pPr>
      <a:lvl2pPr marL="415366" algn="l" defTabSz="830732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830732" algn="l" defTabSz="830732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46099" algn="l" defTabSz="830732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661465" algn="l" defTabSz="830732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2076831" algn="l" defTabSz="830732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492197" algn="l" defTabSz="830732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907563" algn="l" defTabSz="830732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322930" algn="l" defTabSz="830732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Group 32"/>
          <p:cNvGrpSpPr/>
          <p:nvPr/>
        </p:nvGrpSpPr>
        <p:grpSpPr>
          <a:xfrm>
            <a:off x="533400" y="1062868"/>
            <a:ext cx="4367442" cy="6663494"/>
            <a:chOff x="1066800" y="838200"/>
            <a:chExt cx="4367442" cy="6663494"/>
          </a:xfrm>
        </p:grpSpPr>
        <p:sp>
          <p:nvSpPr>
            <p:cNvPr id="34" name="Rectangle 33"/>
            <p:cNvSpPr/>
            <p:nvPr/>
          </p:nvSpPr>
          <p:spPr>
            <a:xfrm>
              <a:off x="1467592" y="1486395"/>
              <a:ext cx="457200" cy="152400"/>
            </a:xfrm>
            <a:prstGeom prst="rect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" name="Rectangle 34"/>
            <p:cNvSpPr/>
            <p:nvPr/>
          </p:nvSpPr>
          <p:spPr>
            <a:xfrm>
              <a:off x="1447800" y="5337957"/>
              <a:ext cx="519545" cy="1620983"/>
            </a:xfrm>
            <a:prstGeom prst="rect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1105469" y="1442292"/>
              <a:ext cx="899378" cy="57819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pAA008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pAA145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0153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0690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1520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2222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2313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2314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2362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2440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3551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3552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3554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3652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4003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4009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4075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4077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4079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4080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4301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4454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4463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4464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4470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4562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4563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4564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4565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4568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4569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4570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4572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4574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4574A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4576</a:t>
              </a:r>
            </a:p>
            <a:p>
              <a:pPr algn="r">
                <a:lnSpc>
                  <a:spcPts val="1200"/>
                </a:lnSpc>
              </a:pPr>
              <a:r>
                <a:rPr lang="en-US" sz="1000" i="1" dirty="0" smtClean="0">
                  <a:latin typeface="Times New Roman" pitchFamily="18" charset="0"/>
                  <a:cs typeface="Times New Roman" pitchFamily="18" charset="0"/>
                </a:rPr>
                <a:t>orf4708</a:t>
              </a:r>
              <a:endParaRPr lang="en-US" sz="1000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37" name="Group 57"/>
            <p:cNvGrpSpPr/>
            <p:nvPr/>
          </p:nvGrpSpPr>
          <p:grpSpPr>
            <a:xfrm>
              <a:off x="2217982" y="7270862"/>
              <a:ext cx="2669688" cy="230832"/>
              <a:chOff x="683112" y="8147583"/>
              <a:chExt cx="2669688" cy="230832"/>
            </a:xfrm>
          </p:grpSpPr>
          <p:sp>
            <p:nvSpPr>
              <p:cNvPr id="57" name="TextBox 56"/>
              <p:cNvSpPr txBox="1"/>
              <p:nvPr/>
            </p:nvSpPr>
            <p:spPr>
              <a:xfrm rot="10800000" flipV="1">
                <a:off x="827984" y="8147583"/>
                <a:ext cx="252481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042              042</a:t>
                </a:r>
                <a:r>
                  <a:rPr lang="en-US" sz="900" i="1" dirty="0" smtClean="0">
                    <a:latin typeface="Times New Roman" pitchFamily="18" charset="0"/>
                    <a:cs typeface="Times New Roman" pitchFamily="18" charset="0"/>
                  </a:rPr>
                  <a:t>aar</a:t>
                </a: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	                042</a:t>
                </a:r>
                <a:r>
                  <a:rPr lang="en-US" sz="900" i="1" dirty="0" smtClean="0">
                    <a:latin typeface="Times New Roman" pitchFamily="18" charset="0"/>
                    <a:cs typeface="Times New Roman" pitchFamily="18" charset="0"/>
                  </a:rPr>
                  <a:t>aar</a:t>
                </a: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(</a:t>
                </a:r>
                <a:r>
                  <a:rPr lang="en-US" sz="900" dirty="0" err="1" smtClean="0">
                    <a:latin typeface="Times New Roman" pitchFamily="18" charset="0"/>
                    <a:cs typeface="Times New Roman" pitchFamily="18" charset="0"/>
                  </a:rPr>
                  <a:t>pAar</a:t>
                </a:r>
                <a:r>
                  <a:rPr lang="en-US" sz="900" dirty="0" smtClean="0">
                    <a:latin typeface="Times New Roman" pitchFamily="18" charset="0"/>
                    <a:cs typeface="Times New Roman" pitchFamily="18" charset="0"/>
                  </a:rPr>
                  <a:t>)</a:t>
                </a:r>
                <a:endParaRPr lang="en-US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8" name="Rectangle 57"/>
              <p:cNvSpPr/>
              <p:nvPr/>
            </p:nvSpPr>
            <p:spPr>
              <a:xfrm>
                <a:off x="683112" y="8241346"/>
                <a:ext cx="170672" cy="49907"/>
              </a:xfrm>
              <a:prstGeom prst="rect">
                <a:avLst/>
              </a:prstGeom>
              <a:solidFill>
                <a:schemeClr val="tx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/>
              </a:p>
            </p:txBody>
          </p:sp>
          <p:sp>
            <p:nvSpPr>
              <p:cNvPr id="59" name="Rectangle 58"/>
              <p:cNvSpPr/>
              <p:nvPr/>
            </p:nvSpPr>
            <p:spPr>
              <a:xfrm>
                <a:off x="1249907" y="8239951"/>
                <a:ext cx="170672" cy="50205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/>
              </a:p>
            </p:txBody>
          </p:sp>
          <p:sp>
            <p:nvSpPr>
              <p:cNvPr id="60" name="Rectangle 59"/>
              <p:cNvSpPr/>
              <p:nvPr/>
            </p:nvSpPr>
            <p:spPr>
              <a:xfrm>
                <a:off x="2053684" y="8240887"/>
                <a:ext cx="170672" cy="48287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 w="3175">
                <a:solidFill>
                  <a:schemeClr val="bg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/>
              </a:p>
            </p:txBody>
          </p:sp>
        </p:grpSp>
        <p:grpSp>
          <p:nvGrpSpPr>
            <p:cNvPr id="38" name="Group 69"/>
            <p:cNvGrpSpPr/>
            <p:nvPr/>
          </p:nvGrpSpPr>
          <p:grpSpPr>
            <a:xfrm>
              <a:off x="1792320" y="838200"/>
              <a:ext cx="2649440" cy="529635"/>
              <a:chOff x="505240" y="792846"/>
              <a:chExt cx="2649440" cy="529635"/>
            </a:xfrm>
          </p:grpSpPr>
          <p:sp>
            <p:nvSpPr>
              <p:cNvPr id="54" name="TextBox 53"/>
              <p:cNvSpPr txBox="1"/>
              <p:nvPr/>
            </p:nvSpPr>
            <p:spPr>
              <a:xfrm>
                <a:off x="505240" y="1014704"/>
                <a:ext cx="203132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/>
                  <a:t>A  	                B	</a:t>
                </a:r>
                <a:endParaRPr lang="en-US" sz="1400" dirty="0"/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977360" y="792846"/>
                <a:ext cx="789547" cy="33827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Read count</a:t>
                </a:r>
                <a:endParaRPr 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56" name="Straight Arrow Connector 55"/>
              <p:cNvCxnSpPr/>
              <p:nvPr/>
            </p:nvCxnSpPr>
            <p:spPr>
              <a:xfrm>
                <a:off x="1868424" y="941832"/>
                <a:ext cx="1286256" cy="9144"/>
              </a:xfrm>
              <a:prstGeom prst="straightConnector1">
                <a:avLst/>
              </a:prstGeom>
              <a:ln>
                <a:solidFill>
                  <a:schemeClr val="accent1"/>
                </a:solidFill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" name="Group 19"/>
            <p:cNvGrpSpPr/>
            <p:nvPr/>
          </p:nvGrpSpPr>
          <p:grpSpPr>
            <a:xfrm>
              <a:off x="1903998" y="876751"/>
              <a:ext cx="3530244" cy="6340601"/>
              <a:chOff x="1218198" y="443657"/>
              <a:chExt cx="3530244" cy="6622382"/>
            </a:xfrm>
          </p:grpSpPr>
          <p:sp>
            <p:nvSpPr>
              <p:cNvPr id="44" name="TextBox 43"/>
              <p:cNvSpPr txBox="1"/>
              <p:nvPr/>
            </p:nvSpPr>
            <p:spPr>
              <a:xfrm rot="5400000">
                <a:off x="3518840" y="-163141"/>
                <a:ext cx="622803" cy="18364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>
                  <a:lnSpc>
                    <a:spcPts val="3400"/>
                  </a:lnSpc>
                </a:pP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3000</a:t>
                </a:r>
              </a:p>
              <a:p>
                <a:pPr algn="r">
                  <a:lnSpc>
                    <a:spcPts val="3400"/>
                  </a:lnSpc>
                </a:pP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2000</a:t>
                </a:r>
              </a:p>
              <a:p>
                <a:pPr algn="r">
                  <a:lnSpc>
                    <a:spcPts val="3400"/>
                  </a:lnSpc>
                </a:pP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1000</a:t>
                </a:r>
              </a:p>
              <a:p>
                <a:pPr algn="r">
                  <a:lnSpc>
                    <a:spcPts val="3400"/>
                  </a:lnSpc>
                </a:pP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0</a:t>
                </a:r>
                <a:endParaRPr lang="en-US" sz="1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pic>
            <p:nvPicPr>
              <p:cNvPr id="45" name="Picture 4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 l="7382"/>
              <a:stretch>
                <a:fillRect/>
              </a:stretch>
            </p:blipFill>
            <p:spPr bwMode="auto">
              <a:xfrm rot="5400000">
                <a:off x="729172" y="3207054"/>
                <a:ext cx="6057093" cy="160469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grpSp>
            <p:nvGrpSpPr>
              <p:cNvPr id="46" name="Group 83"/>
              <p:cNvGrpSpPr/>
              <p:nvPr/>
            </p:nvGrpSpPr>
            <p:grpSpPr>
              <a:xfrm rot="5400000">
                <a:off x="2912026" y="5695760"/>
                <a:ext cx="1852429" cy="757936"/>
                <a:chOff x="4697807" y="7319264"/>
                <a:chExt cx="1414897" cy="757936"/>
              </a:xfrm>
            </p:grpSpPr>
            <p:grpSp>
              <p:nvGrpSpPr>
                <p:cNvPr id="49" name="Group 101"/>
                <p:cNvGrpSpPr/>
                <p:nvPr/>
              </p:nvGrpSpPr>
              <p:grpSpPr>
                <a:xfrm>
                  <a:off x="4697807" y="7507571"/>
                  <a:ext cx="1194534" cy="569629"/>
                  <a:chOff x="4191000" y="2362200"/>
                  <a:chExt cx="1371600" cy="304800"/>
                </a:xfrm>
              </p:grpSpPr>
              <p:cxnSp>
                <p:nvCxnSpPr>
                  <p:cNvPr id="51" name="Straight Connector 50"/>
                  <p:cNvCxnSpPr/>
                  <p:nvPr/>
                </p:nvCxnSpPr>
                <p:spPr>
                  <a:xfrm>
                    <a:off x="4191000" y="2362200"/>
                    <a:ext cx="1371600" cy="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2" name="Straight Connector 51"/>
                  <p:cNvCxnSpPr/>
                  <p:nvPr/>
                </p:nvCxnSpPr>
                <p:spPr>
                  <a:xfrm>
                    <a:off x="4191000" y="2362200"/>
                    <a:ext cx="0" cy="30480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3" name="Straight Connector 52"/>
                  <p:cNvCxnSpPr/>
                  <p:nvPr/>
                </p:nvCxnSpPr>
                <p:spPr>
                  <a:xfrm>
                    <a:off x="5562600" y="2362200"/>
                    <a:ext cx="0" cy="304800"/>
                  </a:xfrm>
                  <a:prstGeom prst="line">
                    <a:avLst/>
                  </a:prstGeom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50" name="TextBox 49"/>
                <p:cNvSpPr txBox="1"/>
                <p:nvPr/>
              </p:nvSpPr>
              <p:spPr>
                <a:xfrm>
                  <a:off x="4854026" y="7319264"/>
                  <a:ext cx="125867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>
                      <a:latin typeface="Times New Roman" pitchFamily="18" charset="0"/>
                      <a:cs typeface="Times New Roman" pitchFamily="18" charset="0"/>
                    </a:rPr>
                    <a:t>Type VI secretion system </a:t>
                  </a:r>
                  <a:endParaRPr lang="en-US" sz="800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pic>
            <p:nvPicPr>
              <p:cNvPr id="47" name="Picture 2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 l="8574"/>
              <a:stretch>
                <a:fillRect/>
              </a:stretch>
            </p:blipFill>
            <p:spPr bwMode="auto">
              <a:xfrm rot="5400000">
                <a:off x="-981809" y="3217205"/>
                <a:ext cx="6083180" cy="16144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48" name="TextBox 47"/>
              <p:cNvSpPr txBox="1"/>
              <p:nvPr/>
            </p:nvSpPr>
            <p:spPr>
              <a:xfrm rot="5400000">
                <a:off x="1746136" y="309"/>
                <a:ext cx="575340" cy="16312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>
                  <a:lnSpc>
                    <a:spcPts val="2000"/>
                  </a:lnSpc>
                </a:pP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1000</a:t>
                </a:r>
              </a:p>
              <a:p>
                <a:pPr algn="r">
                  <a:lnSpc>
                    <a:spcPts val="2000"/>
                  </a:lnSpc>
                </a:pP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800</a:t>
                </a:r>
              </a:p>
              <a:p>
                <a:pPr algn="r">
                  <a:lnSpc>
                    <a:spcPts val="2000"/>
                  </a:lnSpc>
                </a:pP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600</a:t>
                </a:r>
              </a:p>
              <a:p>
                <a:pPr algn="r">
                  <a:lnSpc>
                    <a:spcPts val="2000"/>
                  </a:lnSpc>
                </a:pP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400</a:t>
                </a:r>
              </a:p>
              <a:p>
                <a:pPr algn="r">
                  <a:lnSpc>
                    <a:spcPts val="2000"/>
                  </a:lnSpc>
                </a:pP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200</a:t>
                </a:r>
              </a:p>
              <a:p>
                <a:pPr algn="r">
                  <a:lnSpc>
                    <a:spcPts val="2000"/>
                  </a:lnSpc>
                </a:pP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0</a:t>
                </a:r>
                <a:endParaRPr lang="en-US" sz="1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40" name="Group 79"/>
            <p:cNvGrpSpPr/>
            <p:nvPr/>
          </p:nvGrpSpPr>
          <p:grpSpPr>
            <a:xfrm>
              <a:off x="1066800" y="2057400"/>
              <a:ext cx="276999" cy="4280582"/>
              <a:chOff x="259531" y="2611093"/>
              <a:chExt cx="276999" cy="4755450"/>
            </a:xfrm>
          </p:grpSpPr>
          <p:sp>
            <p:nvSpPr>
              <p:cNvPr id="41" name="TextBox 40"/>
              <p:cNvSpPr txBox="1"/>
              <p:nvPr/>
            </p:nvSpPr>
            <p:spPr>
              <a:xfrm rot="5400000" flipH="1" flipV="1">
                <a:off x="-338421" y="4774105"/>
                <a:ext cx="147290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Transporter proteins</a:t>
                </a:r>
                <a:endParaRPr 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42" name="Straight Connector 41"/>
              <p:cNvCxnSpPr/>
              <p:nvPr/>
            </p:nvCxnSpPr>
            <p:spPr>
              <a:xfrm rot="5400000" flipH="1">
                <a:off x="-293768" y="3333754"/>
                <a:ext cx="1445322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Straight Connector 42"/>
              <p:cNvCxnSpPr/>
              <p:nvPr/>
            </p:nvCxnSpPr>
            <p:spPr>
              <a:xfrm rot="5400000" flipH="1">
                <a:off x="-321200" y="6643882"/>
                <a:ext cx="1445322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8</Words>
  <Application>Microsoft Office PowerPoint</Application>
  <PresentationFormat>Custom</PresentationFormat>
  <Paragraphs>5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raceli</dc:creator>
  <cp:lastModifiedBy>Araceli</cp:lastModifiedBy>
  <cp:revision>1</cp:revision>
  <dcterms:created xsi:type="dcterms:W3CDTF">2017-07-27T17:19:38Z</dcterms:created>
  <dcterms:modified xsi:type="dcterms:W3CDTF">2017-07-27T17:20:54Z</dcterms:modified>
</cp:coreProperties>
</file>